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1" r:id="rId2"/>
  </p:sldIdLst>
  <p:sldSz cx="9144000" cy="6858000" type="screen4x3"/>
  <p:notesSz cx="7010400" cy="92233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70E3098-13B9-4382-8E4F-7137A8F97260}">
          <p14:sldIdLst>
            <p14:sldId id="301"/>
          </p14:sldIdLst>
        </p14:section>
        <p14:section name="Untitled Section" id="{9127215D-B0D2-4D77-97EC-2B7AC063767E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zan, Heba Fathy" initials="AHF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45" autoAdjust="0"/>
    <p:restoredTop sz="94512" autoAdjust="0"/>
  </p:normalViewPr>
  <p:slideViewPr>
    <p:cSldViewPr>
      <p:cViewPr varScale="1">
        <p:scale>
          <a:sx n="74" d="100"/>
          <a:sy n="74" d="100"/>
        </p:scale>
        <p:origin x="113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2FA3D-2F7A-4AA2-95AC-80D01F2A9AF3}" type="datetimeFigureOut">
              <a:rPr lang="en-US" smtClean="0"/>
              <a:t>4/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692150"/>
            <a:ext cx="4610100" cy="3457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1103"/>
            <a:ext cx="5608320" cy="415051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734BAE-C534-479E-A9FC-EAFBA29B5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936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duced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734BAE-C534-479E-A9FC-EAFBA29B50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2213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F5A48E4F-41B3-6641-B11F-2F9068A5302E}"/>
              </a:ext>
            </a:extLst>
          </p:cNvPr>
          <p:cNvGrpSpPr/>
          <p:nvPr/>
        </p:nvGrpSpPr>
        <p:grpSpPr>
          <a:xfrm>
            <a:off x="304800" y="1143000"/>
            <a:ext cx="8686800" cy="3657600"/>
            <a:chOff x="304800" y="1143000"/>
            <a:chExt cx="8686800" cy="36576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8955B13B-F784-2645-8798-EF26F239E3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990600" y="3327118"/>
              <a:ext cx="381000" cy="38956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F516C292-718B-C249-B73E-3E7C7F58CD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990600" y="3790043"/>
              <a:ext cx="381000" cy="389561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27F5DDC2-2661-5C45-AABE-F29FC06ED9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533400" y="3790044"/>
              <a:ext cx="381000" cy="38956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7032CF20-7249-A34A-9EB5-125B5A97C0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1447800" y="3784318"/>
              <a:ext cx="381000" cy="389561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BBBF8D86-62CD-6B44-95A9-95F02AF3A3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1676400" y="4334839"/>
              <a:ext cx="381000" cy="389561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18BD10B3-D19B-264A-8F96-F009768CD7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1219200" y="4334839"/>
              <a:ext cx="381000" cy="38956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xmlns="" id="{72B8B6A1-6030-1F4B-A0AB-3383B029E7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762000" y="4334839"/>
              <a:ext cx="381000" cy="389561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566B7381-5A61-614A-BF2F-DE2EF74485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304800" y="4317718"/>
              <a:ext cx="381000" cy="389561"/>
            </a:xfrm>
            <a:prstGeom prst="rect">
              <a:avLst/>
            </a:prstGeom>
          </p:spPr>
        </p:pic>
        <p:sp>
          <p:nvSpPr>
            <p:cNvPr id="14" name="Rounded Rectangle 13">
              <a:extLst>
                <a:ext uri="{FF2B5EF4-FFF2-40B4-BE49-F238E27FC236}">
                  <a16:creationId xmlns:a16="http://schemas.microsoft.com/office/drawing/2014/main" xmlns="" id="{0352C26D-1425-644A-8784-4BC51AD0170B}"/>
                </a:ext>
              </a:extLst>
            </p:cNvPr>
            <p:cNvSpPr/>
            <p:nvPr/>
          </p:nvSpPr>
          <p:spPr>
            <a:xfrm>
              <a:off x="1066800" y="1143000"/>
              <a:ext cx="2514600" cy="609600"/>
            </a:xfrm>
            <a:prstGeom prst="roundRect">
              <a:avLst/>
            </a:prstGeom>
            <a:solidFill>
              <a:srgbClr val="C00000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mmunized tick group </a:t>
              </a:r>
            </a:p>
          </p:txBody>
        </p:sp>
        <p:sp>
          <p:nvSpPr>
            <p:cNvPr id="15" name="Rounded Rectangle 14">
              <a:extLst>
                <a:ext uri="{FF2B5EF4-FFF2-40B4-BE49-F238E27FC236}">
                  <a16:creationId xmlns:a16="http://schemas.microsoft.com/office/drawing/2014/main" xmlns="" id="{ED5E6185-2F15-5648-A1DD-F1EAD486E2F8}"/>
                </a:ext>
              </a:extLst>
            </p:cNvPr>
            <p:cNvSpPr/>
            <p:nvPr/>
          </p:nvSpPr>
          <p:spPr>
            <a:xfrm>
              <a:off x="5486400" y="1143000"/>
              <a:ext cx="2590800" cy="609600"/>
            </a:xfrm>
            <a:prstGeom prst="roundRect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tick group 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xmlns="" id="{9140D453-3F5F-6849-88E3-58B1BAEF17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3200400" y="3352800"/>
              <a:ext cx="381000" cy="389561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DF76B66A-0BF5-0D4C-9615-33D7D95F2A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3200400" y="3815725"/>
              <a:ext cx="381000" cy="389561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xmlns="" id="{C90F79CF-455D-B84F-ADE7-B0AC7D6FDF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2743200" y="3815726"/>
              <a:ext cx="381000" cy="389561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DE173802-4575-9943-BF8E-929A528377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3657600" y="3810000"/>
              <a:ext cx="381000" cy="389561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xmlns="" id="{6283AE9B-4718-9A4F-87F7-0AC6155EBD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3886200" y="4360521"/>
              <a:ext cx="381000" cy="389561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xmlns="" id="{3ED9469A-2A74-624F-9773-39547FE35C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3429000" y="4360521"/>
              <a:ext cx="381000" cy="389561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xmlns="" id="{99B15AFC-2D69-EB4B-85A3-F86379B778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2971800" y="4360521"/>
              <a:ext cx="381000" cy="389561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xmlns="" id="{E3F5BCF4-26EA-4D48-A6B4-E504437C71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2514600" y="4343400"/>
              <a:ext cx="381000" cy="389561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xmlns="" id="{EE1BC615-5A98-9945-AEE6-4C06E43520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5638800" y="3403318"/>
              <a:ext cx="381000" cy="389561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xmlns="" id="{BD6EBF23-BFD5-004A-B98E-7F2906B877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5638800" y="3866243"/>
              <a:ext cx="381000" cy="389561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xmlns="" id="{DF4C94DB-77AA-1C41-920D-9DC631468B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5181600" y="3866244"/>
              <a:ext cx="381000" cy="389561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xmlns="" id="{6A027770-D92B-4944-AE16-B1DCE60A42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6096000" y="3860518"/>
              <a:ext cx="381000" cy="389561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xmlns="" id="{C8D264F6-E76D-A848-B1CB-8840DA5594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6324600" y="4411039"/>
              <a:ext cx="381000" cy="389561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xmlns="" id="{A4E8A1D3-D0E7-DC42-81EF-45FD75BC99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5867400" y="4411039"/>
              <a:ext cx="381000" cy="389561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xmlns="" id="{AF63A81A-D795-804B-8633-BA269DC665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5410200" y="4411039"/>
              <a:ext cx="381000" cy="389561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xmlns="" id="{DBB10264-8E17-E54B-BC20-644A1A6EAE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4953000" y="4393918"/>
              <a:ext cx="381000" cy="389561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xmlns="" id="{E8B7A108-C1AF-FB4A-B69D-BE04AB876F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7924800" y="3403318"/>
              <a:ext cx="381000" cy="389561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xmlns="" id="{BD728042-7082-5D47-AEE9-EEDA6BCEA0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7924800" y="3866243"/>
              <a:ext cx="381000" cy="389561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xmlns="" id="{8B5339CD-8CB3-4345-9DEE-56295E8033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7467600" y="3866244"/>
              <a:ext cx="381000" cy="389561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xmlns="" id="{40995C1C-C018-F248-84BB-46616078A5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8382000" y="3860518"/>
              <a:ext cx="381000" cy="389561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xmlns="" id="{C7613DBC-E710-6841-B4B6-C4027B9D4F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8610600" y="4411039"/>
              <a:ext cx="381000" cy="389561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xmlns="" id="{9BA57C65-5E6D-DD48-99D2-454A98B274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8153400" y="4411039"/>
              <a:ext cx="381000" cy="389561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xmlns="" id="{9236ED5F-36F9-7D48-A3CB-7F68AC6AEF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7696200" y="4411039"/>
              <a:ext cx="381000" cy="389561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xmlns="" id="{0CA3D6C3-EB6C-C344-90BF-671FBB0D70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303" t="6172"/>
            <a:stretch/>
          </p:blipFill>
          <p:spPr>
            <a:xfrm>
              <a:off x="7239000" y="4393918"/>
              <a:ext cx="381000" cy="389561"/>
            </a:xfrm>
            <a:prstGeom prst="rect">
              <a:avLst/>
            </a:prstGeom>
          </p:spPr>
        </p:pic>
        <p:sp>
          <p:nvSpPr>
            <p:cNvPr id="40" name="Left Brace 39">
              <a:extLst>
                <a:ext uri="{FF2B5EF4-FFF2-40B4-BE49-F238E27FC236}">
                  <a16:creationId xmlns:a16="http://schemas.microsoft.com/office/drawing/2014/main" xmlns="" id="{4794618C-8575-564F-A860-0C2510022065}"/>
                </a:ext>
              </a:extLst>
            </p:cNvPr>
            <p:cNvSpPr/>
            <p:nvPr/>
          </p:nvSpPr>
          <p:spPr>
            <a:xfrm rot="5400000">
              <a:off x="2025032" y="1460574"/>
              <a:ext cx="521936" cy="2286000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Left Brace 40">
              <a:extLst>
                <a:ext uri="{FF2B5EF4-FFF2-40B4-BE49-F238E27FC236}">
                  <a16:creationId xmlns:a16="http://schemas.microsoft.com/office/drawing/2014/main" xmlns="" id="{406415BB-54D1-6E40-B5E6-2F99518FA71E}"/>
                </a:ext>
              </a:extLst>
            </p:cNvPr>
            <p:cNvSpPr/>
            <p:nvPr/>
          </p:nvSpPr>
          <p:spPr>
            <a:xfrm rot="5400000">
              <a:off x="6448704" y="1323697"/>
              <a:ext cx="513789" cy="2438401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xmlns="" id="{BA55ACDA-7BCD-8441-B082-7E3A563405CE}"/>
                </a:ext>
              </a:extLst>
            </p:cNvPr>
            <p:cNvSpPr/>
            <p:nvPr/>
          </p:nvSpPr>
          <p:spPr>
            <a:xfrm>
              <a:off x="1479877" y="1845846"/>
              <a:ext cx="173477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roduced larvae 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xmlns="" id="{96F7DAFA-8AF7-C846-A156-32B3E9645D28}"/>
                </a:ext>
              </a:extLst>
            </p:cNvPr>
            <p:cNvSpPr/>
            <p:nvPr/>
          </p:nvSpPr>
          <p:spPr>
            <a:xfrm>
              <a:off x="5785177" y="1828800"/>
              <a:ext cx="173477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roduced larvae 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xmlns="" id="{112E27EF-8202-3440-9CA6-654D07755944}"/>
                </a:ext>
              </a:extLst>
            </p:cNvPr>
            <p:cNvSpPr/>
            <p:nvPr/>
          </p:nvSpPr>
          <p:spPr>
            <a:xfrm>
              <a:off x="637752" y="2901196"/>
              <a:ext cx="148470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nduced (35 </a:t>
              </a:r>
              <a:r>
                <a:rPr lang="en-US" sz="14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xmlns="" id="{4031A939-A20A-DC4B-A161-6A4DE45E25CB}"/>
                </a:ext>
              </a:extLst>
            </p:cNvPr>
            <p:cNvSpPr/>
            <p:nvPr/>
          </p:nvSpPr>
          <p:spPr>
            <a:xfrm>
              <a:off x="5100215" y="2895600"/>
              <a:ext cx="151676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nduced (35 </a:t>
              </a:r>
              <a:r>
                <a:rPr lang="en-US" sz="14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xmlns="" id="{ED2F85E5-45B7-0C4A-9067-D9B9E987B51A}"/>
                </a:ext>
              </a:extLst>
            </p:cNvPr>
            <p:cNvSpPr/>
            <p:nvPr/>
          </p:nvSpPr>
          <p:spPr>
            <a:xfrm>
              <a:off x="2590800" y="2895600"/>
              <a:ext cx="187262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on-Induced (26 </a:t>
              </a:r>
              <a:r>
                <a:rPr lang="en-US" sz="14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xmlns="" id="{02A8357A-E4A8-E741-9BAE-2D52AF6F49E4}"/>
                </a:ext>
              </a:extLst>
            </p:cNvPr>
            <p:cNvSpPr/>
            <p:nvPr/>
          </p:nvSpPr>
          <p:spPr>
            <a:xfrm>
              <a:off x="7086600" y="2895600"/>
              <a:ext cx="190468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on-Induced (26 </a:t>
              </a:r>
              <a:r>
                <a:rPr lang="en-US" sz="14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785F475-1A0F-BB49-8D0D-CDE91856C87A}"/>
              </a:ext>
            </a:extLst>
          </p:cNvPr>
          <p:cNvSpPr txBox="1"/>
          <p:nvPr/>
        </p:nvSpPr>
        <p:spPr>
          <a:xfrm>
            <a:off x="8244153" y="6211669"/>
            <a:ext cx="732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3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6044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42</TotalTime>
  <Words>33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zan, Heba Fathy</dc:creator>
  <cp:lastModifiedBy>Pon Abirami A.</cp:lastModifiedBy>
  <cp:revision>178</cp:revision>
  <dcterms:created xsi:type="dcterms:W3CDTF">2020-04-03T19:59:23Z</dcterms:created>
  <dcterms:modified xsi:type="dcterms:W3CDTF">2021-04-07T08:06:00Z</dcterms:modified>
</cp:coreProperties>
</file>